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02438" cy="9934575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159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7F7F7F"/>
    <a:srgbClr val="646464"/>
    <a:srgbClr val="8282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69" autoAdjust="0"/>
    <p:restoredTop sz="94084" autoAdjust="0"/>
  </p:normalViewPr>
  <p:slideViewPr>
    <p:cSldViewPr snapToGrid="0" snapToObjects="1">
      <p:cViewPr varScale="1">
        <p:scale>
          <a:sx n="59" d="100"/>
          <a:sy n="59" d="100"/>
        </p:scale>
        <p:origin x="1920" y="68"/>
      </p:cViewPr>
      <p:guideLst>
        <p:guide orient="horz" pos="2880"/>
        <p:guide pos="2160"/>
        <p:guide orient="horz" pos="159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845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47343F-9011-4E48-ACD0-AFDBFF8B6C7E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1241425"/>
            <a:ext cx="2513012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244" y="4781014"/>
            <a:ext cx="5441950" cy="39117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141" y="9436123"/>
            <a:ext cx="2947723" cy="49845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F467D0-B869-419D-8DA9-B631581B19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3186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733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524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469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4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62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2652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60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198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747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419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34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lt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0B96C7-68D0-B647-8A30-6FA99E508E04}" type="datetimeFigureOut">
              <a:rPr kumimoji="1" lang="ja-JP" altLang="en-US" smtClean="0"/>
              <a:t>2018/7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2BDFD-0760-2A46-9C31-F1E2C89CB06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645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302806" y="368376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BMC</a:t>
            </a:r>
          </a:p>
        </p:txBody>
      </p:sp>
      <p:cxnSp>
        <p:nvCxnSpPr>
          <p:cNvPr id="3" name="直線矢印コネクタ 2"/>
          <p:cNvCxnSpPr/>
          <p:nvPr/>
        </p:nvCxnSpPr>
        <p:spPr>
          <a:xfrm flipH="1">
            <a:off x="2606741" y="4414056"/>
            <a:ext cx="27025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/>
          <p:cNvSpPr txBox="1"/>
          <p:nvPr/>
        </p:nvSpPr>
        <p:spPr>
          <a:xfrm>
            <a:off x="2946739" y="5153301"/>
            <a:ext cx="1291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Brefeldin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A</a:t>
            </a:r>
          </a:p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2.5 </a:t>
            </a:r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μg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/mL)</a:t>
            </a:r>
            <a:endParaRPr lang="ja-JP" altLang="en-US" sz="9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622141" y="5637362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3 </a:t>
            </a:r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r</a:t>
            </a:r>
            <a:endParaRPr lang="ja-JP" altLang="en-US" sz="9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622141" y="4749530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2 </a:t>
            </a:r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hr</a:t>
            </a:r>
            <a:endParaRPr lang="ja-JP" altLang="en-US" sz="9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09691" y="6382843"/>
            <a:ext cx="9412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ACS analysis</a:t>
            </a:r>
          </a:p>
        </p:txBody>
      </p:sp>
      <p:cxnSp>
        <p:nvCxnSpPr>
          <p:cNvPr id="8" name="直線矢印コネクタ 7"/>
          <p:cNvCxnSpPr/>
          <p:nvPr/>
        </p:nvCxnSpPr>
        <p:spPr>
          <a:xfrm flipH="1">
            <a:off x="2618681" y="5302984"/>
            <a:ext cx="27025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2946739" y="4258660"/>
            <a:ext cx="1114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Loxoribine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(1 </a:t>
            </a:r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M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)</a:t>
            </a:r>
          </a:p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CpG2216</a:t>
            </a:r>
            <a:r>
              <a:rPr lang="ja-JP" altLang="en-US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(2 </a:t>
            </a:r>
            <a:r>
              <a:rPr lang="en-US" altLang="ja-JP" sz="900" dirty="0" err="1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mM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41103" y="1286907"/>
            <a:ext cx="16786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hole blood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(SLE, RA and HC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869114" y="1286907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BMC (HC)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451211" y="1625830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Pre-treatment </a:t>
            </a:r>
          </a:p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 with cytokine</a:t>
            </a:r>
          </a:p>
        </p:txBody>
      </p:sp>
      <p:cxnSp>
        <p:nvCxnSpPr>
          <p:cNvPr id="13" name="直線矢印コネクタ 12"/>
          <p:cNvCxnSpPr/>
          <p:nvPr/>
        </p:nvCxnSpPr>
        <p:spPr>
          <a:xfrm flipH="1">
            <a:off x="4133936" y="1591833"/>
            <a:ext cx="1705" cy="1022473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/>
          <p:cNvCxnSpPr/>
          <p:nvPr/>
        </p:nvCxnSpPr>
        <p:spPr>
          <a:xfrm flipH="1">
            <a:off x="4166164" y="1789773"/>
            <a:ext cx="27025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3944774" y="2611088"/>
            <a:ext cx="14542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wash</a:t>
            </a:r>
            <a:r>
              <a:rPr lang="ja-JP" altLang="en-US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9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to remove cytokine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798362" y="3181520"/>
            <a:ext cx="6791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/>
          <p:cNvCxnSpPr/>
          <p:nvPr/>
        </p:nvCxnSpPr>
        <p:spPr>
          <a:xfrm flipH="1">
            <a:off x="4133936" y="2876878"/>
            <a:ext cx="1" cy="282305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/>
          <p:cNvCxnSpPr/>
          <p:nvPr/>
        </p:nvCxnSpPr>
        <p:spPr>
          <a:xfrm flipH="1">
            <a:off x="2879846" y="3382908"/>
            <a:ext cx="942774" cy="33198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3247672" y="840129"/>
            <a:ext cx="20911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 vitro pre-treatment with cytokine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/>
          <p:cNvCxnSpPr/>
          <p:nvPr/>
        </p:nvCxnSpPr>
        <p:spPr>
          <a:xfrm>
            <a:off x="2553680" y="4023079"/>
            <a:ext cx="0" cy="2296796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4233881" y="2151538"/>
            <a:ext cx="9815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, 12, 24 </a:t>
            </a:r>
            <a:r>
              <a:rPr lang="en-US" altLang="ja-JP" sz="9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55502" y="2073769"/>
            <a:ext cx="1730099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solation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any soluble factors </a:t>
            </a: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        were removed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39655" y="837547"/>
            <a:ext cx="1835734" cy="2334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LR7/9 responses (ex vivo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626596" y="3181520"/>
            <a:ext cx="6791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BMC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/>
          <p:cNvCxnSpPr/>
          <p:nvPr/>
        </p:nvCxnSpPr>
        <p:spPr>
          <a:xfrm>
            <a:off x="859906" y="1758777"/>
            <a:ext cx="0" cy="136941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1244095" y="3382908"/>
            <a:ext cx="999821" cy="313899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8621325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1</TotalTime>
  <Words>76</Words>
  <Application>Microsoft Office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ＭＳ Ｐゴシック</vt:lpstr>
      <vt:lpstr>Arial</vt:lpstr>
      <vt:lpstr>Calibri</vt:lpstr>
      <vt:lpstr>ホワイト</vt:lpstr>
      <vt:lpstr>PowerPoint プレゼンテーション</vt:lpstr>
    </vt:vector>
  </TitlesOfParts>
  <Company>UOE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TA SHIGERU</dc:creator>
  <cp:lastModifiedBy>圭 阪田</cp:lastModifiedBy>
  <cp:revision>283</cp:revision>
  <cp:lastPrinted>2017-04-10T01:20:45Z</cp:lastPrinted>
  <dcterms:created xsi:type="dcterms:W3CDTF">2016-08-30T03:40:23Z</dcterms:created>
  <dcterms:modified xsi:type="dcterms:W3CDTF">2018-07-25T02:19:13Z</dcterms:modified>
</cp:coreProperties>
</file>